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1" d="100"/>
          <a:sy n="91" d="100"/>
        </p:scale>
        <p:origin x="351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B050719-475A-844E-8C78-E065BDCDBE5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ADABD8FB-281D-D850-19F8-C5AD717DC10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3BB7830-FBCA-5D94-F0B1-4E28021287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63D15-5897-4DF3-ABEB-19706BFF28E7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34718B1-A122-6094-6D98-C97C436BD3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F3277AA-7DDD-22E8-B3B4-3FDF4FCD39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6203A-6F53-4C3E-8F0E-91C37725B4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1780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4B8BBF9-BDF6-4CE0-52A9-AA9A5F7F4F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65732F0-0273-E2DD-310E-4B64D2579DC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6B9BEDF-BA2D-5BF3-3DF4-40EC76D497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63D15-5897-4DF3-ABEB-19706BFF28E7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A4E8717-781F-1071-E0F4-0E6EC97F88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E52071B-C6F3-98BA-294B-608C47C9E9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6203A-6F53-4C3E-8F0E-91C37725B4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44215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7EA6C7BF-CECC-0441-5985-C8FF40F9848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F29986C-0C2D-D6B6-FF67-19E4A63394A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469CBD6-A4D2-1EC7-0C6C-07B9D105F6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63D15-5897-4DF3-ABEB-19706BFF28E7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3F402D6-7BB4-E01F-F110-224875B6CB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1B23060-0EE1-54FA-2C08-F0E2224E8F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6203A-6F53-4C3E-8F0E-91C37725B4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30473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064363B-D810-DE7E-A838-384B812BC8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606D2AD-4CE9-D7F4-B457-71EDA05A8E5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4F1EFC6-2E1F-4553-4603-6CCFD5352E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63D15-5897-4DF3-ABEB-19706BFF28E7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A0FF229-4CEE-F286-7BB6-E26A56AB5D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BA4C40D-08C3-C544-7CB8-9C74EE0507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6203A-6F53-4C3E-8F0E-91C37725B4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0789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4FD8BB9-8F7B-3364-62DA-F6FDEAB41A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3DBA552-3EA8-9660-4891-93A7A72AC8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12179C7-AEA1-85AC-54EB-E226D55AF8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63D15-5897-4DF3-ABEB-19706BFF28E7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0E7E68B-C3AC-D726-D972-607D4F73AC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D4BC4A9-14B0-9DAB-CD5E-2B83F26966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6203A-6F53-4C3E-8F0E-91C37725B4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11420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41B9406-DE2D-96AC-434E-457AE5EB75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4990E69-BBC2-AA43-67EA-050D3D2E775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0EEB3B2-C910-C1A1-5CF7-001AB7B2E0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35B27C4-F4B0-CD75-A30B-11027FEE26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63D15-5897-4DF3-ABEB-19706BFF28E7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240D878-92BC-BCC1-3B73-11BA954291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FBE1EA4-4EAE-0705-8FF7-57D094422E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6203A-6F53-4C3E-8F0E-91C37725B4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475262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290FCF2-B1BF-C3CC-5AE8-759AA03DCF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51D7782-A2BB-6BBD-0622-D441B18A7D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51ACAB1-D564-790F-3950-0F815B1CFF7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AAAC3E65-A77E-4BA8-21BE-6DDA2250C2E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80765347-8215-F6D7-746E-154401558EA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E8C122D0-D883-BCFF-419F-81763ED1B2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63D15-5897-4DF3-ABEB-19706BFF28E7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7C393955-1A2D-66D4-2125-728CEA8973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BE6EABD9-C1FD-FA9E-A324-1DB18165F0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6203A-6F53-4C3E-8F0E-91C37725B4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404760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2153A9F-49CF-979B-D55A-EBA4DE3F4A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8B6BBA33-F681-BAFD-D011-D7F9394543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63D15-5897-4DF3-ABEB-19706BFF28E7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EC5C954D-AFFB-CA27-B66F-0A48AFE5C2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E2B1B852-C995-A1DA-F470-665D86742D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6203A-6F53-4C3E-8F0E-91C37725B4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33739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2FAE89AA-6479-DD43-773B-359AE0C716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63D15-5897-4DF3-ABEB-19706BFF28E7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C1713BDE-21E8-AE95-3FE9-33109BF1D5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FC0A0F17-C3A5-1469-8F35-E668DBE037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6203A-6F53-4C3E-8F0E-91C37725B4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2940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80773B0-C283-B955-D440-36060181AB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57AC70D-1A72-499A-4793-6B0BBB50A5B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A8E74CF-933D-F5C7-181D-7CC0329B9E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B24C285-3CCD-94FC-AB8D-8F6D568E2A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63D15-5897-4DF3-ABEB-19706BFF28E7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EA5A421-38BC-18EF-A75B-F33524E54D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8EEA3D2-F54D-81AE-4B84-9A112311B3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6203A-6F53-4C3E-8F0E-91C37725B4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97834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AEC83BB-7EAD-391D-EFED-2D0B85D804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2097582-01AC-149B-79E5-53BCDA78D2A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430BAFF-F1AC-38D6-5181-E42D2EEC20B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D3C6763-EF52-5B4F-DC0A-12D4423EB6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63D15-5897-4DF3-ABEB-19706BFF28E7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1FB2E4D-CF64-1591-D7DA-469BEA755B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9AFFC6F-8D9A-EEB4-926B-D08D2BAC13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6203A-6F53-4C3E-8F0E-91C37725B4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06504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EABB9D11-98E8-FA3E-9B57-928D11F4FB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7EFE4DD-B494-1A29-E2C9-E965225C8C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46C1956-8797-C16D-FF0C-A670312F5FE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F63D15-5897-4DF3-ABEB-19706BFF28E7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A6052D7-91C1-B85F-7BF2-F57735591AE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1977ED7-0316-DA15-70B4-1A402FAA862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06203A-6F53-4C3E-8F0E-91C37725B4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95509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F11E3350-588E-F5FB-72B9-0F8E716E461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87123625"/>
              </p:ext>
            </p:extLst>
          </p:nvPr>
        </p:nvGraphicFramePr>
        <p:xfrm>
          <a:off x="2739258" y="1416837"/>
          <a:ext cx="6713483" cy="3456310"/>
        </p:xfrm>
        <a:graphic>
          <a:graphicData uri="http://schemas.openxmlformats.org/drawingml/2006/table">
            <a:tbl>
              <a:tblPr firstRow="1" firstCol="1" bandRow="1"/>
              <a:tblGrid>
                <a:gridCol w="1881072">
                  <a:extLst>
                    <a:ext uri="{9D8B030D-6E8A-4147-A177-3AD203B41FA5}">
                      <a16:colId xmlns:a16="http://schemas.microsoft.com/office/drawing/2014/main" val="2689967121"/>
                    </a:ext>
                  </a:extLst>
                </a:gridCol>
                <a:gridCol w="1149136">
                  <a:extLst>
                    <a:ext uri="{9D8B030D-6E8A-4147-A177-3AD203B41FA5}">
                      <a16:colId xmlns:a16="http://schemas.microsoft.com/office/drawing/2014/main" val="756259577"/>
                    </a:ext>
                  </a:extLst>
                </a:gridCol>
                <a:gridCol w="1881072">
                  <a:extLst>
                    <a:ext uri="{9D8B030D-6E8A-4147-A177-3AD203B41FA5}">
                      <a16:colId xmlns:a16="http://schemas.microsoft.com/office/drawing/2014/main" val="1236603251"/>
                    </a:ext>
                  </a:extLst>
                </a:gridCol>
                <a:gridCol w="1802203">
                  <a:extLst>
                    <a:ext uri="{9D8B030D-6E8A-4147-A177-3AD203B41FA5}">
                      <a16:colId xmlns:a16="http://schemas.microsoft.com/office/drawing/2014/main" val="2018389948"/>
                    </a:ext>
                  </a:extLst>
                </a:gridCol>
              </a:tblGrid>
              <a:tr h="305005">
                <a:tc rowSpan="2"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Subinhibitory concentration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Antibiotics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Concentration</a:t>
                      </a:r>
                      <a:r>
                        <a:rPr lang="zh-CN" sz="12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sz="1200" kern="1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μg</a:t>
                      </a:r>
                      <a:r>
                        <a:rPr lang="en-US" sz="12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/mL</a:t>
                      </a:r>
                      <a:r>
                        <a:rPr lang="zh-CN" sz="12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）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6513366"/>
                  </a:ext>
                </a:extLst>
              </a:tr>
              <a:tr h="348929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917</a:t>
                      </a:r>
                      <a:r>
                        <a:rPr lang="en-US" sz="12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Δ</a:t>
                      </a:r>
                      <a:r>
                        <a:rPr lang="en-US" sz="1200" i="1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asd</a:t>
                      </a:r>
                      <a:r>
                        <a:rPr lang="en-US" sz="12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/I2-C600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917</a:t>
                      </a: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Δ</a:t>
                      </a:r>
                      <a:r>
                        <a:rPr lang="en-US" sz="1200" i="1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asd</a:t>
                      </a: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/I2-700603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66511739"/>
                  </a:ext>
                </a:extLst>
              </a:tr>
              <a:tr h="306643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 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AMP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5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5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20732436"/>
                  </a:ext>
                </a:extLst>
              </a:tr>
              <a:tr h="306643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/2MIC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AMC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3599028"/>
                  </a:ext>
                </a:extLst>
              </a:tr>
              <a:tr h="306643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 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CEP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4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4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54575159"/>
                  </a:ext>
                </a:extLst>
              </a:tr>
              <a:tr h="306643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 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AMP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25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25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09862372"/>
                  </a:ext>
                </a:extLst>
              </a:tr>
              <a:tr h="306643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/4MIC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AMC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22791270"/>
                  </a:ext>
                </a:extLst>
              </a:tr>
              <a:tr h="306643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 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CEP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54294070"/>
                  </a:ext>
                </a:extLst>
              </a:tr>
              <a:tr h="306643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 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AMP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125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125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2229871"/>
                  </a:ext>
                </a:extLst>
              </a:tr>
              <a:tr h="306643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/8MIC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AMC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5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5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46211599"/>
                  </a:ext>
                </a:extLst>
              </a:tr>
              <a:tr h="306643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 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CEP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48730560"/>
                  </a:ext>
                </a:extLst>
              </a:tr>
            </a:tbl>
          </a:graphicData>
        </a:graphic>
      </p:graphicFrame>
      <p:sp>
        <p:nvSpPr>
          <p:cNvPr id="3" name="文本框 2">
            <a:extLst>
              <a:ext uri="{FF2B5EF4-FFF2-40B4-BE49-F238E27FC236}">
                <a16:creationId xmlns:a16="http://schemas.microsoft.com/office/drawing/2014/main" id="{163A5DD9-1F33-F484-91CD-13ADF3F6BE76}"/>
              </a:ext>
            </a:extLst>
          </p:cNvPr>
          <p:cNvSpPr txBox="1"/>
          <p:nvPr/>
        </p:nvSpPr>
        <p:spPr>
          <a:xfrm>
            <a:off x="3121571" y="4873146"/>
            <a:ext cx="4682359" cy="40902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zh-CN" sz="12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MP: ampicillin; AMC: amoxicillin/clavulanic acid; CEP: cephalexin.</a:t>
            </a:r>
            <a:endParaRPr lang="zh-CN" altLang="zh-CN" sz="1200" kern="100" dirty="0">
              <a:effectLst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179747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66</Words>
  <Application>Microsoft Office PowerPoint</Application>
  <PresentationFormat>宽屏</PresentationFormat>
  <Paragraphs>4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Kaidi Liu</dc:creator>
  <cp:lastModifiedBy>Kaidi Liu</cp:lastModifiedBy>
  <cp:revision>3</cp:revision>
  <dcterms:created xsi:type="dcterms:W3CDTF">2024-02-22T07:47:41Z</dcterms:created>
  <dcterms:modified xsi:type="dcterms:W3CDTF">2024-02-22T08:05:59Z</dcterms:modified>
</cp:coreProperties>
</file>